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5AD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3"/>
    <p:restoredTop sz="94694"/>
  </p:normalViewPr>
  <p:slideViewPr>
    <p:cSldViewPr snapToGrid="0">
      <p:cViewPr varScale="1">
        <p:scale>
          <a:sx n="117" d="100"/>
          <a:sy n="117" d="100"/>
        </p:scale>
        <p:origin x="34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E07909-2B78-184D-80C3-BBC99EE490AD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60FF4E-0FA4-9647-B3DA-29766D33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296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60FF4E-0FA4-9647-B3DA-29766D33710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15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7B7B1-3EBB-D568-54DF-920DCFB8CF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D834C1-E831-CB29-F5D3-AAA8472A1A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9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96" indent="0" algn="ctr">
              <a:buNone/>
              <a:defRPr sz="2000"/>
            </a:lvl2pPr>
            <a:lvl3pPr marL="914391" indent="0" algn="ctr">
              <a:buNone/>
              <a:defRPr sz="1800"/>
            </a:lvl3pPr>
            <a:lvl4pPr marL="1371587" indent="0" algn="ctr">
              <a:buNone/>
              <a:defRPr sz="1600"/>
            </a:lvl4pPr>
            <a:lvl5pPr marL="1828783" indent="0" algn="ctr">
              <a:buNone/>
              <a:defRPr sz="1600"/>
            </a:lvl5pPr>
            <a:lvl6pPr marL="2285978" indent="0" algn="ctr">
              <a:buNone/>
              <a:defRPr sz="1600"/>
            </a:lvl6pPr>
            <a:lvl7pPr marL="2743174" indent="0" algn="ctr">
              <a:buNone/>
              <a:defRPr sz="1600"/>
            </a:lvl7pPr>
            <a:lvl8pPr marL="3200370" indent="0" algn="ctr">
              <a:buNone/>
              <a:defRPr sz="1600"/>
            </a:lvl8pPr>
            <a:lvl9pPr marL="3657565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01C99-7DB3-5D08-D757-93891C21E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255B42-5BFC-F3F6-ED48-35E1492B4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538E05-392A-A538-DA21-4E2BB06A4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124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C33A8-60AE-633A-38C6-91F50F5195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AE8818-8715-D75B-6DCA-244E28CB12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3C64B1-748D-6E3A-968F-4341C9F15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E91691-179D-9628-4216-BA1AECC6B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3DE635-E9FD-E607-6914-63C65D37D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337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E348FD-DBBE-0D64-4028-4394D18B81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0E6248-2ED3-BDC7-AE7A-49C6058A0E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70D8B-DB8C-58D3-8E16-10E5EAED3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F0824-DD62-C41E-A1DC-9FF54E5F5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21457B-115B-FFC1-9196-9AD6215FE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833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67DDD1-58E6-D758-3029-D2C7554343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AF614-ED41-7EC6-DE2E-2830E33698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44C052-8C3D-CB7C-85EA-E065B41F8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8967E-3B5A-875A-B50F-49A1DBD58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2521CD-7DAB-9B36-C8EA-F7684E74E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730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07384-1696-66C4-F92A-AC1AF5DFB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D3A51B-8731-D1BE-3FD5-C434BCEE98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96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91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8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8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7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7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7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65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C7020-3AED-7E52-A503-6B90EC38A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EE003A-3DA8-46E2-B450-F5F78AB93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D133B-112E-3AD8-A2BE-BC715996B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459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B8210-C560-C35F-3320-2B09FB94C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0107D9-E6AB-3A17-F8CD-3C143B4D7B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1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95A86C-8008-4857-C1DC-7552526E21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1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A9314-A970-9B12-D816-9B7E8F57A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13C983-F406-E2A4-C68B-8F2DE3C26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CB4244-156C-4B9B-5F21-11B165058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766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598E0-4835-2B71-7EB2-D89C6901F8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7C6266-6AD3-2305-2951-C664D0152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1" indent="0">
              <a:buNone/>
              <a:defRPr sz="1800" b="1"/>
            </a:lvl3pPr>
            <a:lvl4pPr marL="1371587" indent="0">
              <a:buNone/>
              <a:defRPr sz="1600" b="1"/>
            </a:lvl4pPr>
            <a:lvl5pPr marL="1828783" indent="0">
              <a:buNone/>
              <a:defRPr sz="1600" b="1"/>
            </a:lvl5pPr>
            <a:lvl6pPr marL="2285978" indent="0">
              <a:buNone/>
              <a:defRPr sz="1600" b="1"/>
            </a:lvl6pPr>
            <a:lvl7pPr marL="2743174" indent="0">
              <a:buNone/>
              <a:defRPr sz="1600" b="1"/>
            </a:lvl7pPr>
            <a:lvl8pPr marL="3200370" indent="0">
              <a:buNone/>
              <a:defRPr sz="1600" b="1"/>
            </a:lvl8pPr>
            <a:lvl9pPr marL="3657565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B427B1-A684-230D-FBAF-052F24F43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0E9505-5C6B-9E8C-579A-D18C32F966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1" indent="0">
              <a:buNone/>
              <a:defRPr sz="1800" b="1"/>
            </a:lvl3pPr>
            <a:lvl4pPr marL="1371587" indent="0">
              <a:buNone/>
              <a:defRPr sz="1600" b="1"/>
            </a:lvl4pPr>
            <a:lvl5pPr marL="1828783" indent="0">
              <a:buNone/>
              <a:defRPr sz="1600" b="1"/>
            </a:lvl5pPr>
            <a:lvl6pPr marL="2285978" indent="0">
              <a:buNone/>
              <a:defRPr sz="1600" b="1"/>
            </a:lvl6pPr>
            <a:lvl7pPr marL="2743174" indent="0">
              <a:buNone/>
              <a:defRPr sz="1600" b="1"/>
            </a:lvl7pPr>
            <a:lvl8pPr marL="3200370" indent="0">
              <a:buNone/>
              <a:defRPr sz="1600" b="1"/>
            </a:lvl8pPr>
            <a:lvl9pPr marL="3657565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236D4D-ED23-EA97-5F70-A23D7BC46E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3EE409-F86A-3C05-FEA0-CB6971F6F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413176-FDD1-9497-D2BA-58792E633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89336C-FD99-E6DB-87DC-A3746E2C1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116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CE10A-2FA2-5627-7C7E-475C2F6CB5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16D2C0-1D77-D566-2F31-293225763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0883B4-F271-1D1F-62F9-1006F7AB2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B4C762-6F76-539A-6553-7FD854BFF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433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51FD69-15EC-5875-5F23-CD380119C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83EB62-7C94-F93A-524D-9E5CF245A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B9931E-9729-10A3-91EE-A76AAD067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44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5A15FB-8021-6BE1-E8B9-3981E1B0B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3A793-63E3-0E7B-F8A1-42F9E5B148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9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3AA671-A20A-0CE9-6829-A4DF22B33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96" indent="0">
              <a:buNone/>
              <a:defRPr sz="1400"/>
            </a:lvl2pPr>
            <a:lvl3pPr marL="914391" indent="0">
              <a:buNone/>
              <a:defRPr sz="1200"/>
            </a:lvl3pPr>
            <a:lvl4pPr marL="1371587" indent="0">
              <a:buNone/>
              <a:defRPr sz="1000"/>
            </a:lvl4pPr>
            <a:lvl5pPr marL="1828783" indent="0">
              <a:buNone/>
              <a:defRPr sz="1000"/>
            </a:lvl5pPr>
            <a:lvl6pPr marL="2285978" indent="0">
              <a:buNone/>
              <a:defRPr sz="1000"/>
            </a:lvl6pPr>
            <a:lvl7pPr marL="2743174" indent="0">
              <a:buNone/>
              <a:defRPr sz="1000"/>
            </a:lvl7pPr>
            <a:lvl8pPr marL="3200370" indent="0">
              <a:buNone/>
              <a:defRPr sz="1000"/>
            </a:lvl8pPr>
            <a:lvl9pPr marL="3657565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9EBF7-10CD-0BBC-86ED-6E3850BAF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26D15D-7B02-AFCD-3431-4E8CAF151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22990A-35F2-D937-86C0-8ABED3A24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13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54E84B-BBCD-5AEF-963D-7E563E70D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1612A8-DDE0-EE40-539E-73BD932936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9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96" indent="0">
              <a:buNone/>
              <a:defRPr sz="2800"/>
            </a:lvl2pPr>
            <a:lvl3pPr marL="914391" indent="0">
              <a:buNone/>
              <a:defRPr sz="2400"/>
            </a:lvl3pPr>
            <a:lvl4pPr marL="1371587" indent="0">
              <a:buNone/>
              <a:defRPr sz="2000"/>
            </a:lvl4pPr>
            <a:lvl5pPr marL="1828783" indent="0">
              <a:buNone/>
              <a:defRPr sz="2000"/>
            </a:lvl5pPr>
            <a:lvl6pPr marL="2285978" indent="0">
              <a:buNone/>
              <a:defRPr sz="2000"/>
            </a:lvl6pPr>
            <a:lvl7pPr marL="2743174" indent="0">
              <a:buNone/>
              <a:defRPr sz="2000"/>
            </a:lvl7pPr>
            <a:lvl8pPr marL="3200370" indent="0">
              <a:buNone/>
              <a:defRPr sz="2000"/>
            </a:lvl8pPr>
            <a:lvl9pPr marL="3657565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F95247-71AB-F7F9-6E2C-14DFBB1766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96" indent="0">
              <a:buNone/>
              <a:defRPr sz="1400"/>
            </a:lvl2pPr>
            <a:lvl3pPr marL="914391" indent="0">
              <a:buNone/>
              <a:defRPr sz="1200"/>
            </a:lvl3pPr>
            <a:lvl4pPr marL="1371587" indent="0">
              <a:buNone/>
              <a:defRPr sz="1000"/>
            </a:lvl4pPr>
            <a:lvl5pPr marL="1828783" indent="0">
              <a:buNone/>
              <a:defRPr sz="1000"/>
            </a:lvl5pPr>
            <a:lvl6pPr marL="2285978" indent="0">
              <a:buNone/>
              <a:defRPr sz="1000"/>
            </a:lvl6pPr>
            <a:lvl7pPr marL="2743174" indent="0">
              <a:buNone/>
              <a:defRPr sz="1000"/>
            </a:lvl7pPr>
            <a:lvl8pPr marL="3200370" indent="0">
              <a:buNone/>
              <a:defRPr sz="1000"/>
            </a:lvl8pPr>
            <a:lvl9pPr marL="3657565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D716B9-0C38-DD01-1809-FFA2050CC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D72947-5D21-C642-EA98-091401123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E6EA80-92BF-E946-E63B-499BB7B77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202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AC36B8-00BE-65BF-E2DE-0C8AF4B15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929556-2BCC-5D1D-DD11-04085BB468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A9A28C-7B37-0EBC-DF77-BA592E800B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987347-67C2-894C-BDB3-108C01158786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79796B-AE82-6BF6-B025-11E1400B03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C9BD1-2BE7-77FC-CD6F-1616351DA1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52B8BA-BFE5-294C-A58A-E1425B7547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015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9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8" indent="-228598" algn="l" defTabSz="91439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93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89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85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0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76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72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67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63" indent="-228598" algn="l" defTabSz="91439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6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1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7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3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78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74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70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65" algn="l" defTabSz="91439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AA661D0-88F6-8363-22D7-257FDA02FCBB}"/>
              </a:ext>
            </a:extLst>
          </p:cNvPr>
          <p:cNvGrpSpPr/>
          <p:nvPr/>
        </p:nvGrpSpPr>
        <p:grpSpPr>
          <a:xfrm>
            <a:off x="158044" y="92740"/>
            <a:ext cx="11552711" cy="6315667"/>
            <a:chOff x="158044" y="92740"/>
            <a:chExt cx="11552711" cy="631566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61C918C-D2F4-2E36-A8BC-4A91934EB898}"/>
                </a:ext>
              </a:extLst>
            </p:cNvPr>
            <p:cNvSpPr/>
            <p:nvPr/>
          </p:nvSpPr>
          <p:spPr>
            <a:xfrm>
              <a:off x="590137" y="1344127"/>
              <a:ext cx="1600200" cy="4709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A0B8CB3-994E-5EB7-04E2-5F55E886C40C}"/>
                </a:ext>
              </a:extLst>
            </p:cNvPr>
            <p:cNvSpPr txBox="1"/>
            <p:nvPr/>
          </p:nvSpPr>
          <p:spPr>
            <a:xfrm>
              <a:off x="588572" y="880496"/>
              <a:ext cx="1573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Evidence-practice gap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FB316E7-0D9C-4E88-C9DA-6B8A11848DAA}"/>
                </a:ext>
              </a:extLst>
            </p:cNvPr>
            <p:cNvSpPr txBox="1"/>
            <p:nvPr/>
          </p:nvSpPr>
          <p:spPr>
            <a:xfrm>
              <a:off x="2524080" y="880496"/>
              <a:ext cx="149352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Evidence-based practic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40ECAB2-E13C-D3B0-0A94-F08E6F0F4CFD}"/>
                </a:ext>
              </a:extLst>
            </p:cNvPr>
            <p:cNvSpPr txBox="1"/>
            <p:nvPr/>
          </p:nvSpPr>
          <p:spPr>
            <a:xfrm>
              <a:off x="4725550" y="1003496"/>
              <a:ext cx="12481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Determinant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5683AAA-80EA-7366-9594-34BA4521179F}"/>
                </a:ext>
              </a:extLst>
            </p:cNvPr>
            <p:cNvSpPr txBox="1"/>
            <p:nvPr/>
          </p:nvSpPr>
          <p:spPr>
            <a:xfrm>
              <a:off x="7494256" y="6100630"/>
              <a:ext cx="42164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/>
                <a:t>Denote social ecological levels using superscripts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AFA843-B9AC-5B3F-C7AA-8BF48009405A}"/>
                </a:ext>
              </a:extLst>
            </p:cNvPr>
            <p:cNvSpPr txBox="1"/>
            <p:nvPr/>
          </p:nvSpPr>
          <p:spPr>
            <a:xfrm>
              <a:off x="6574209" y="845665"/>
              <a:ext cx="14551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Change objectives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9101B4A-5F99-ED87-2664-B739696C7E8C}"/>
                </a:ext>
              </a:extLst>
            </p:cNvPr>
            <p:cNvSpPr txBox="1"/>
            <p:nvPr/>
          </p:nvSpPr>
          <p:spPr>
            <a:xfrm>
              <a:off x="8374866" y="857478"/>
              <a:ext cx="14551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Implementation Strategies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D7C12B2-3D47-3B5E-1C2A-FACFAB34E746}"/>
                </a:ext>
              </a:extLst>
            </p:cNvPr>
            <p:cNvSpPr txBox="1"/>
            <p:nvPr/>
          </p:nvSpPr>
          <p:spPr>
            <a:xfrm>
              <a:off x="8374866" y="3489400"/>
              <a:ext cx="14551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Mechanisms of Chang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98DF91B-FCE1-5376-C378-ED502CE52DE7}"/>
                </a:ext>
              </a:extLst>
            </p:cNvPr>
            <p:cNvSpPr txBox="1"/>
            <p:nvPr/>
          </p:nvSpPr>
          <p:spPr>
            <a:xfrm>
              <a:off x="10112558" y="1052252"/>
              <a:ext cx="14551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utcomes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E0DD965A-34E1-DFD2-6A66-F7C4FCC96454}"/>
                </a:ext>
              </a:extLst>
            </p:cNvPr>
            <p:cNvSpPr/>
            <p:nvPr/>
          </p:nvSpPr>
          <p:spPr>
            <a:xfrm>
              <a:off x="158044" y="92740"/>
              <a:ext cx="4075289" cy="6140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Research Question: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0778DB9C-307B-E78D-9228-09956C1AA279}"/>
                </a:ext>
              </a:extLst>
            </p:cNvPr>
            <p:cNvGrpSpPr/>
            <p:nvPr/>
          </p:nvGrpSpPr>
          <p:grpSpPr>
            <a:xfrm>
              <a:off x="2527353" y="1340685"/>
              <a:ext cx="1600200" cy="4709160"/>
              <a:chOff x="2121608" y="1463546"/>
              <a:chExt cx="1600200" cy="4698835"/>
            </a:xfrm>
          </p:grpSpPr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20CA9B9E-3A11-F0A2-C672-6E8AA576C2AD}"/>
                  </a:ext>
                </a:extLst>
              </p:cNvPr>
              <p:cNvSpPr/>
              <p:nvPr/>
            </p:nvSpPr>
            <p:spPr>
              <a:xfrm>
                <a:off x="2121608" y="1463546"/>
                <a:ext cx="1600200" cy="469883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22F28780-D5B5-30E7-6E8D-8C6936A31655}"/>
                  </a:ext>
                </a:extLst>
              </p:cNvPr>
              <p:cNvSpPr/>
              <p:nvPr/>
            </p:nvSpPr>
            <p:spPr>
              <a:xfrm>
                <a:off x="2194128" y="2951836"/>
                <a:ext cx="1455159" cy="129288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465E210-3211-719C-17D0-92A4806946AB}"/>
                  </a:ext>
                </a:extLst>
              </p:cNvPr>
              <p:cNvSpPr txBox="1"/>
              <p:nvPr/>
            </p:nvSpPr>
            <p:spPr>
              <a:xfrm>
                <a:off x="2183814" y="2419707"/>
                <a:ext cx="145515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Core Components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18E1836-FC61-D098-E7B6-AC92ADBA0347}"/>
                  </a:ext>
                </a:extLst>
              </p:cNvPr>
              <p:cNvSpPr txBox="1"/>
              <p:nvPr/>
            </p:nvSpPr>
            <p:spPr>
              <a:xfrm>
                <a:off x="2145449" y="4228290"/>
                <a:ext cx="149352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daptable components</a:t>
                </a:r>
              </a:p>
            </p:txBody>
          </p: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DA1C2CB1-DD8E-CEAD-B6AF-44B305B75F15}"/>
                  </a:ext>
                </a:extLst>
              </p:cNvPr>
              <p:cNvSpPr/>
              <p:nvPr/>
            </p:nvSpPr>
            <p:spPr>
              <a:xfrm>
                <a:off x="2194128" y="4798368"/>
                <a:ext cx="1455159" cy="13022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060A5ECD-1910-C6D5-39A2-88CD9E0C8CB6}"/>
                </a:ext>
              </a:extLst>
            </p:cNvPr>
            <p:cNvSpPr/>
            <p:nvPr/>
          </p:nvSpPr>
          <p:spPr>
            <a:xfrm>
              <a:off x="4567746" y="1360030"/>
              <a:ext cx="1600200" cy="4709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F44C2415-4A05-EE37-705F-E776A76B169E}"/>
                </a:ext>
              </a:extLst>
            </p:cNvPr>
            <p:cNvSpPr/>
            <p:nvPr/>
          </p:nvSpPr>
          <p:spPr>
            <a:xfrm>
              <a:off x="6501689" y="1340685"/>
              <a:ext cx="1600200" cy="4709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434BB114-72EF-662D-A59D-C516D8F7D81D}"/>
                </a:ext>
              </a:extLst>
            </p:cNvPr>
            <p:cNvSpPr/>
            <p:nvPr/>
          </p:nvSpPr>
          <p:spPr>
            <a:xfrm>
              <a:off x="8293907" y="1351043"/>
              <a:ext cx="1600200" cy="20779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CC646D13-56E1-AEF9-E220-64F77D2719CA}"/>
                </a:ext>
              </a:extLst>
            </p:cNvPr>
            <p:cNvSpPr/>
            <p:nvPr/>
          </p:nvSpPr>
          <p:spPr>
            <a:xfrm>
              <a:off x="8302346" y="4012621"/>
              <a:ext cx="1600200" cy="20646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335312E-348D-72EE-E5C2-25A09047DB84}"/>
                </a:ext>
              </a:extLst>
            </p:cNvPr>
            <p:cNvSpPr/>
            <p:nvPr/>
          </p:nvSpPr>
          <p:spPr>
            <a:xfrm>
              <a:off x="9975066" y="1351043"/>
              <a:ext cx="1727078" cy="47262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544161"/>
              <a:endParaRPr lang="en-US" sz="1612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E2A54697-A047-DC44-622F-6A27EF265285}"/>
                </a:ext>
              </a:extLst>
            </p:cNvPr>
            <p:cNvSpPr/>
            <p:nvPr/>
          </p:nvSpPr>
          <p:spPr>
            <a:xfrm>
              <a:off x="10086125" y="1448730"/>
              <a:ext cx="1338597" cy="18277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544161"/>
              <a:endParaRPr lang="en-US" sz="1200" dirty="0">
                <a:solidFill>
                  <a:schemeClr val="tx1"/>
                </a:solidFill>
                <a:latin typeface="Calibri" panose="020F0502020204030204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654F355-6988-D6C2-47A1-56D622E88046}"/>
                </a:ext>
              </a:extLst>
            </p:cNvPr>
            <p:cNvSpPr/>
            <p:nvPr/>
          </p:nvSpPr>
          <p:spPr>
            <a:xfrm>
              <a:off x="10065162" y="4767470"/>
              <a:ext cx="1338597" cy="11983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544161"/>
              <a:endParaRPr lang="en-US" sz="1100" dirty="0">
                <a:solidFill>
                  <a:schemeClr val="tx1"/>
                </a:solidFill>
                <a:latin typeface="Calibri" panose="020F0502020204030204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9F7CDFC4-2BA8-5244-BCE0-EBB9D426CB94}"/>
                </a:ext>
              </a:extLst>
            </p:cNvPr>
            <p:cNvSpPr/>
            <p:nvPr/>
          </p:nvSpPr>
          <p:spPr>
            <a:xfrm>
              <a:off x="10109443" y="3488750"/>
              <a:ext cx="1338597" cy="11027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544161"/>
              <a:endParaRPr lang="en-US" sz="1200" baseline="30000" dirty="0">
                <a:solidFill>
                  <a:schemeClr val="tx1"/>
                </a:solidFill>
                <a:latin typeface="Calibri" panose="020F0502020204030204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6322E80-AFA1-F4A2-EB1C-FD65631241C1}"/>
                </a:ext>
              </a:extLst>
            </p:cNvPr>
            <p:cNvSpPr txBox="1"/>
            <p:nvPr/>
          </p:nvSpPr>
          <p:spPr>
            <a:xfrm rot="5400000">
              <a:off x="10658403" y="2151042"/>
              <a:ext cx="1827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44161"/>
              <a:r>
                <a:rPr lang="en-US" sz="1200" dirty="0">
                  <a:solidFill>
                    <a:prstClr val="black"/>
                  </a:solidFill>
                  <a:latin typeface="Arial" charset="0"/>
                  <a:ea typeface="Arial" charset="0"/>
                  <a:cs typeface="Arial" charset="0"/>
                </a:rPr>
                <a:t>Implementatio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C8C98AD-706B-42EE-4C5C-FCE608F765FA}"/>
                </a:ext>
              </a:extLst>
            </p:cNvPr>
            <p:cNvSpPr txBox="1"/>
            <p:nvPr/>
          </p:nvSpPr>
          <p:spPr>
            <a:xfrm rot="5400000">
              <a:off x="11179574" y="3886418"/>
              <a:ext cx="785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44161"/>
              <a:r>
                <a:rPr lang="en-US" sz="1200" dirty="0">
                  <a:solidFill>
                    <a:prstClr val="black"/>
                  </a:solidFill>
                  <a:latin typeface="Arial" charset="0"/>
                  <a:ea typeface="Arial" charset="0"/>
                  <a:cs typeface="Arial" charset="0"/>
                </a:rPr>
                <a:t>Proces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AC830BC-698A-4CA9-220F-6F398257BAD7}"/>
                </a:ext>
              </a:extLst>
            </p:cNvPr>
            <p:cNvSpPr txBox="1"/>
            <p:nvPr/>
          </p:nvSpPr>
          <p:spPr>
            <a:xfrm rot="5400000">
              <a:off x="10852773" y="5270771"/>
              <a:ext cx="13750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44161"/>
              <a:r>
                <a:rPr lang="en-US" sz="1200" dirty="0">
                  <a:solidFill>
                    <a:prstClr val="black"/>
                  </a:solidFill>
                  <a:latin typeface="Arial" charset="0"/>
                  <a:ea typeface="Arial" charset="0"/>
                  <a:cs typeface="Arial" charset="0"/>
                </a:rPr>
                <a:t>Effectivenes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81108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4</TotalTime>
  <Words>30</Words>
  <Application>Microsoft Macintosh PowerPoint</Application>
  <PresentationFormat>Widescreen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shcraft, Lauraellen</dc:creator>
  <cp:lastModifiedBy>Ashcraft, Lauraellen</cp:lastModifiedBy>
  <cp:revision>22</cp:revision>
  <dcterms:created xsi:type="dcterms:W3CDTF">2024-09-19T14:13:31Z</dcterms:created>
  <dcterms:modified xsi:type="dcterms:W3CDTF">2025-09-19T13:19:12Z</dcterms:modified>
</cp:coreProperties>
</file>